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12192000" cy="6858000"/>
  <p:notesSz cx="6858000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9" autoAdjust="0"/>
    <p:restoredTop sz="94660"/>
  </p:normalViewPr>
  <p:slideViewPr>
    <p:cSldViewPr snapToGrid="0">
      <p:cViewPr>
        <p:scale>
          <a:sx n="66" d="100"/>
          <a:sy n="66" d="100"/>
        </p:scale>
        <p:origin x="1086" y="13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C5DA0082-D22E-4AF8-8014-7F7700485E5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xmlns="" id="{C5F746AD-172D-4B3B-8CC6-A252581C468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09FE9F9E-89ED-4987-B490-8FA71F1201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26A2A-5B29-450D-A51B-CE73B28D47B0}" type="datetimeFigureOut">
              <a:rPr lang="ko-KR" altLang="en-US" smtClean="0"/>
              <a:t>2021-07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20C78963-D598-4C49-B520-503FD46E81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179B4631-1ED7-423A-9A4B-BE9C61D804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1EE01-DA39-4EA8-8AD0-E0DFAF6D659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863893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F94F86F1-09DA-46BA-B45D-9899092195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xmlns="" id="{03D3E37D-D57F-4665-B4D6-A82C853719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D4E9F87C-A023-422E-A424-D20819CD83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26A2A-5B29-450D-A51B-CE73B28D47B0}" type="datetimeFigureOut">
              <a:rPr lang="ko-KR" altLang="en-US" smtClean="0"/>
              <a:t>2021-07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1009D76A-5D5E-4460-A843-BB10F9E861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DC9B962A-0A80-4DE8-A634-EA6EF6C6B6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1EE01-DA39-4EA8-8AD0-E0DFAF6D659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602876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xmlns="" id="{3F9A9593-F26E-4D83-93C3-A9FBC3A7375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xmlns="" id="{97DCB4C8-0365-4810-AC9D-C16543CB8A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7126B62F-13D8-4FCF-8BA0-CA990B80DE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26A2A-5B29-450D-A51B-CE73B28D47B0}" type="datetimeFigureOut">
              <a:rPr lang="ko-KR" altLang="en-US" smtClean="0"/>
              <a:t>2021-07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E28FD397-F3B9-4060-9337-3917F7DD6A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B5283BAE-BD4E-427A-8958-2599C06D0F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1EE01-DA39-4EA8-8AD0-E0DFAF6D659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465843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203DE7A6-ADEF-43DB-A95F-89A4501F9C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xmlns="" id="{E9379841-F415-43C9-8915-565EEC0C73D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530664A6-7C39-4E8A-A877-707B105C66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26A2A-5B29-450D-A51B-CE73B28D47B0}" type="datetimeFigureOut">
              <a:rPr lang="ko-KR" altLang="en-US" smtClean="0"/>
              <a:t>2021-07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BA221A49-1A9A-4AB9-94F0-CE6FDACCB7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40668631-F94C-4279-B6DC-152834BBBA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1EE01-DA39-4EA8-8AD0-E0DFAF6D659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825589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40B8F841-23F3-4A37-BBA2-17D18A1559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xmlns="" id="{F0F64803-F0B2-4A64-97D4-59A9FD0822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4665B643-63E6-4349-9CDD-3B6BC1234C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26A2A-5B29-450D-A51B-CE73B28D47B0}" type="datetimeFigureOut">
              <a:rPr lang="ko-KR" altLang="en-US" smtClean="0"/>
              <a:t>2021-07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2720EB4B-9F5F-4ACC-8D64-CBE176801D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6C25195C-1607-4B88-9B28-1430DA0B3C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1EE01-DA39-4EA8-8AD0-E0DFAF6D659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6806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15762BAF-065A-4F1B-BC86-AF3C757D6F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xmlns="" id="{6A35FDE8-C36D-4385-84FD-B290103256C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xmlns="" id="{1F8CEFCA-8AB3-4CA7-8E56-5B55E55F823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xmlns="" id="{71DF981D-CF27-46C9-838A-46F4D1785C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26A2A-5B29-450D-A51B-CE73B28D47B0}" type="datetimeFigureOut">
              <a:rPr lang="ko-KR" altLang="en-US" smtClean="0"/>
              <a:t>2021-07-1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xmlns="" id="{58FA59C1-1E6E-4C98-9764-C47EE78DC4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xmlns="" id="{E5007FE7-2D4F-47AD-93D6-58844B0F08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1EE01-DA39-4EA8-8AD0-E0DFAF6D659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434778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3D46CA53-0920-450C-AA75-3FB437278B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xmlns="" id="{A9C1A033-401D-4042-A35D-BA8A4D2BC8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xmlns="" id="{00BB90DF-FC47-4C1E-AB80-F03DAF99DC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xmlns="" id="{3B546892-9900-4D20-B8B6-03ECBBE724D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xmlns="" id="{6E31CB59-FAC2-4126-B09C-D5552ED319D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xmlns="" id="{834D272A-C379-40F5-921D-93120BE481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26A2A-5B29-450D-A51B-CE73B28D47B0}" type="datetimeFigureOut">
              <a:rPr lang="ko-KR" altLang="en-US" smtClean="0"/>
              <a:t>2021-07-12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xmlns="" id="{40014A6D-A4E5-4732-9283-4F3F80538C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xmlns="" id="{3E95D968-2FE9-4C01-AAC1-7BFE0564EE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1EE01-DA39-4EA8-8AD0-E0DFAF6D659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147467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A3019BF4-5E01-4F05-B55F-0B236A0F4C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xmlns="" id="{5F685FD6-4320-4F51-A6F5-F0CC521199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26A2A-5B29-450D-A51B-CE73B28D47B0}" type="datetimeFigureOut">
              <a:rPr lang="ko-KR" altLang="en-US" smtClean="0"/>
              <a:t>2021-07-12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xmlns="" id="{A8E84BC0-D9D3-4930-8803-C7EBE4B8E8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xmlns="" id="{DE97ABFA-BC8B-420A-8FFD-F39316123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1EE01-DA39-4EA8-8AD0-E0DFAF6D659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86797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xmlns="" id="{D65A616B-DFAA-45D2-85DE-959D068F03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26A2A-5B29-450D-A51B-CE73B28D47B0}" type="datetimeFigureOut">
              <a:rPr lang="ko-KR" altLang="en-US" smtClean="0"/>
              <a:t>2021-07-12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xmlns="" id="{F1EFAC53-D757-42DD-A093-9FCC4BAFE3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xmlns="" id="{01955FB4-E293-4F4A-905A-67FB12B890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1EE01-DA39-4EA8-8AD0-E0DFAF6D659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616767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60200D19-8B75-4588-BD4F-C6EF75AB9E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xmlns="" id="{0DE24643-5861-41B2-9F19-5943C2A36D8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xmlns="" id="{6663CFD4-18A5-45BC-A265-0FE5BB5B20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xmlns="" id="{C56D0FAD-356E-4F55-A562-9C964332BE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26A2A-5B29-450D-A51B-CE73B28D47B0}" type="datetimeFigureOut">
              <a:rPr lang="ko-KR" altLang="en-US" smtClean="0"/>
              <a:t>2021-07-1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xmlns="" id="{E9BD69F8-C108-4D61-9FC3-5AB3A68FFB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xmlns="" id="{7C4C137B-AE94-4160-A6AF-5A8C439BBF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1EE01-DA39-4EA8-8AD0-E0DFAF6D659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85521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7B179756-1B1D-4B81-87F1-26DFD36768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xmlns="" id="{18696B2F-4C01-488A-996D-65667AFA54A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xmlns="" id="{308C6E29-E458-4B9E-B6CD-4ED72C7795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xmlns="" id="{93FEF844-E8D6-46B5-842F-5CCD62518F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26A2A-5B29-450D-A51B-CE73B28D47B0}" type="datetimeFigureOut">
              <a:rPr lang="ko-KR" altLang="en-US" smtClean="0"/>
              <a:t>2021-07-1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xmlns="" id="{4D8AEA00-F507-4006-8EE7-349325E213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xmlns="" id="{788D4BE5-55CE-4A89-B30D-300F31EE15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1EE01-DA39-4EA8-8AD0-E0DFAF6D659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491672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xmlns="" id="{D92456E3-4188-4A1F-8E3A-E7E0C585C9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xmlns="" id="{910B6F8F-49AA-43E1-8F64-A7F0530540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1AEC21F9-369B-4D75-AE55-3621A4964A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626A2A-5B29-450D-A51B-CE73B28D47B0}" type="datetimeFigureOut">
              <a:rPr lang="ko-KR" altLang="en-US" smtClean="0"/>
              <a:t>2021-07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89C60F43-187E-43FA-89B4-DF4F5B5ECBF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78AAB6E8-7A7E-4FAF-A7CA-BB50514B14F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A1EE01-DA39-4EA8-8AD0-E0DFAF6D659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860061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13E24B41-A803-4425-B627-A75D2879D5C3}"/>
              </a:ext>
            </a:extLst>
          </p:cNvPr>
          <p:cNvSpPr txBox="1"/>
          <p:nvPr/>
        </p:nvSpPr>
        <p:spPr>
          <a:xfrm>
            <a:off x="368373" y="491040"/>
            <a:ext cx="114285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detection rate of eight respiratory viruses in 2020 and recent 4 years (2016–2019).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lch’s t-test was applied for the statistical analysis.</a:t>
            </a:r>
            <a:endParaRPr lang="ko-KR" altLang="en-US" b="1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그림 7">
            <a:extLst>
              <a:ext uri="{FF2B5EF4-FFF2-40B4-BE49-F238E27FC236}">
                <a16:creationId xmlns:a16="http://schemas.microsoft.com/office/drawing/2014/main" xmlns="" id="{079A7D6B-757A-488A-829D-1B0D4E9ACE6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570" y="1137371"/>
            <a:ext cx="12022122" cy="5720629"/>
          </a:xfrm>
          <a:prstGeom prst="rect">
            <a:avLst/>
          </a:prstGeom>
        </p:spPr>
      </p:pic>
      <p:sp>
        <p:nvSpPr>
          <p:cNvPr id="5" name="직사각형 4"/>
          <p:cNvSpPr/>
          <p:nvPr/>
        </p:nvSpPr>
        <p:spPr>
          <a:xfrm>
            <a:off x="0" y="0"/>
            <a:ext cx="2762250" cy="49104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4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ko-KR" alt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terial 1</a:t>
            </a:r>
            <a:endParaRPr lang="ko-KR" altLang="en-US" sz="1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55911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404</TotalTime>
  <Words>29</Words>
  <Application>Microsoft Office PowerPoint</Application>
  <PresentationFormat>와이드스크린</PresentationFormat>
  <Paragraphs>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 은정</dc:creator>
  <cp:lastModifiedBy>admin</cp:lastModifiedBy>
  <cp:revision>257</cp:revision>
  <cp:lastPrinted>2021-06-20T01:42:39Z</cp:lastPrinted>
  <dcterms:created xsi:type="dcterms:W3CDTF">2021-05-02T14:32:08Z</dcterms:created>
  <dcterms:modified xsi:type="dcterms:W3CDTF">2021-07-12T05:02:31Z</dcterms:modified>
</cp:coreProperties>
</file>